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7"/>
  </p:notesMasterIdLst>
  <p:sldIdLst>
    <p:sldId id="278" r:id="rId2"/>
    <p:sldId id="280" r:id="rId3"/>
    <p:sldId id="279" r:id="rId4"/>
    <p:sldId id="270" r:id="rId5"/>
    <p:sldId id="257" r:id="rId6"/>
  </p:sldIdLst>
  <p:sldSz cx="73152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174"/>
    <p:restoredTop sz="95988"/>
  </p:normalViewPr>
  <p:slideViewPr>
    <p:cSldViewPr snapToGrid="0" snapToObjects="1">
      <p:cViewPr>
        <p:scale>
          <a:sx n="150" d="100"/>
          <a:sy n="150" d="100"/>
        </p:scale>
        <p:origin x="163" y="-28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20024B7-962A-5545-9B55-9C26E9D52A1A}" type="datetimeFigureOut">
              <a:rPr lang="en-US" smtClean="0"/>
              <a:t>7/26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06638" y="1143000"/>
            <a:ext cx="2244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EED67D9-AB20-7A47-9A9B-805A05E05E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982335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306638" y="1143000"/>
            <a:ext cx="224472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upplementary Table 1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EB5C818-1D63-6449-AE0A-BC3D451C9363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325853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48640" y="1646133"/>
            <a:ext cx="6217920" cy="3501813"/>
          </a:xfrm>
        </p:spPr>
        <p:txBody>
          <a:bodyPr anchor="b"/>
          <a:lstStyle>
            <a:lvl1pPr algn="ctr"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14400" y="5282989"/>
            <a:ext cx="5486400" cy="2428451"/>
          </a:xfrm>
        </p:spPr>
        <p:txBody>
          <a:bodyPr/>
          <a:lstStyle>
            <a:lvl1pPr marL="0" indent="0" algn="ctr">
              <a:buNone/>
              <a:defRPr sz="1920"/>
            </a:lvl1pPr>
            <a:lvl2pPr marL="365760" indent="0" algn="ctr">
              <a:buNone/>
              <a:defRPr sz="1600"/>
            </a:lvl2pPr>
            <a:lvl3pPr marL="731520" indent="0" algn="ctr">
              <a:buNone/>
              <a:defRPr sz="1440"/>
            </a:lvl3pPr>
            <a:lvl4pPr marL="1097280" indent="0" algn="ctr">
              <a:buNone/>
              <a:defRPr sz="1280"/>
            </a:lvl4pPr>
            <a:lvl5pPr marL="1463040" indent="0" algn="ctr">
              <a:buNone/>
              <a:defRPr sz="1280"/>
            </a:lvl5pPr>
            <a:lvl6pPr marL="1828800" indent="0" algn="ctr">
              <a:buNone/>
              <a:defRPr sz="1280"/>
            </a:lvl6pPr>
            <a:lvl7pPr marL="2194560" indent="0" algn="ctr">
              <a:buNone/>
              <a:defRPr sz="1280"/>
            </a:lvl7pPr>
            <a:lvl8pPr marL="2560320" indent="0" algn="ctr">
              <a:buNone/>
              <a:defRPr sz="1280"/>
            </a:lvl8pPr>
            <a:lvl9pPr marL="2926080" indent="0" algn="ctr">
              <a:buNone/>
              <a:defRPr sz="128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6E8328-4258-9945-8338-038BE48D0508}" type="datetimeFigureOut">
              <a:rPr lang="en-US" smtClean="0"/>
              <a:t>7/2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D63DF0-34A7-064F-94E6-7FA832E74F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28156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6E8328-4258-9945-8338-038BE48D0508}" type="datetimeFigureOut">
              <a:rPr lang="en-US" smtClean="0"/>
              <a:t>7/2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D63DF0-34A7-064F-94E6-7FA832E74F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83128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234940" y="535517"/>
            <a:ext cx="1577340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02920" y="535517"/>
            <a:ext cx="4640580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6E8328-4258-9945-8338-038BE48D0508}" type="datetimeFigureOut">
              <a:rPr lang="en-US" smtClean="0"/>
              <a:t>7/2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D63DF0-34A7-064F-94E6-7FA832E74F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33768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6E8328-4258-9945-8338-038BE48D0508}" type="datetimeFigureOut">
              <a:rPr lang="en-US" smtClean="0"/>
              <a:t>7/2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D63DF0-34A7-064F-94E6-7FA832E74F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02678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9110" y="2507618"/>
            <a:ext cx="6309360" cy="4184014"/>
          </a:xfrm>
        </p:spPr>
        <p:txBody>
          <a:bodyPr anchor="b"/>
          <a:lstStyle>
            <a:lvl1pPr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9110" y="6731215"/>
            <a:ext cx="6309360" cy="2200274"/>
          </a:xfrm>
        </p:spPr>
        <p:txBody>
          <a:bodyPr/>
          <a:lstStyle>
            <a:lvl1pPr marL="0" indent="0">
              <a:buNone/>
              <a:defRPr sz="1920">
                <a:solidFill>
                  <a:schemeClr val="tx1"/>
                </a:solidFill>
              </a:defRPr>
            </a:lvl1pPr>
            <a:lvl2pPr marL="36576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73152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3pPr>
            <a:lvl4pPr marL="10972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4pPr>
            <a:lvl5pPr marL="146304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5pPr>
            <a:lvl6pPr marL="182880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6pPr>
            <a:lvl7pPr marL="219456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7pPr>
            <a:lvl8pPr marL="256032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8pPr>
            <a:lvl9pPr marL="29260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6E8328-4258-9945-8338-038BE48D0508}" type="datetimeFigureOut">
              <a:rPr lang="en-US" smtClean="0"/>
              <a:t>7/2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D63DF0-34A7-064F-94E6-7FA832E74F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27552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02920" y="2677584"/>
            <a:ext cx="310896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03320" y="2677584"/>
            <a:ext cx="310896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6E8328-4258-9945-8338-038BE48D0508}" type="datetimeFigureOut">
              <a:rPr lang="en-US" smtClean="0"/>
              <a:t>7/2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D63DF0-34A7-064F-94E6-7FA832E74F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38531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535519"/>
            <a:ext cx="6309360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3874" y="2465706"/>
            <a:ext cx="3094672" cy="1208404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3874" y="3674110"/>
            <a:ext cx="309467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703320" y="2465706"/>
            <a:ext cx="3109913" cy="1208404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703320" y="3674110"/>
            <a:ext cx="3109913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6E8328-4258-9945-8338-038BE48D0508}" type="datetimeFigureOut">
              <a:rPr lang="en-US" smtClean="0"/>
              <a:t>7/26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D63DF0-34A7-064F-94E6-7FA832E74F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89045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6E8328-4258-9945-8338-038BE48D0508}" type="datetimeFigureOut">
              <a:rPr lang="en-US" smtClean="0"/>
              <a:t>7/26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D63DF0-34A7-064F-94E6-7FA832E74F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89032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6E8328-4258-9945-8338-038BE48D0508}" type="datetimeFigureOut">
              <a:rPr lang="en-US" smtClean="0"/>
              <a:t>7/26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D63DF0-34A7-064F-94E6-7FA832E74F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6131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670560"/>
            <a:ext cx="2359342" cy="2346960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109913" y="1448226"/>
            <a:ext cx="3703320" cy="7147983"/>
          </a:xfrm>
        </p:spPr>
        <p:txBody>
          <a:bodyPr/>
          <a:lstStyle>
            <a:lvl1pPr>
              <a:defRPr sz="2560"/>
            </a:lvl1pPr>
            <a:lvl2pPr>
              <a:defRPr sz="2240"/>
            </a:lvl2pPr>
            <a:lvl3pPr>
              <a:defRPr sz="192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3017520"/>
            <a:ext cx="2359342" cy="5590329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6E8328-4258-9945-8338-038BE48D0508}" type="datetimeFigureOut">
              <a:rPr lang="en-US" smtClean="0"/>
              <a:t>7/2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D63DF0-34A7-064F-94E6-7FA832E74F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3216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670560"/>
            <a:ext cx="2359342" cy="2346960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109913" y="1448226"/>
            <a:ext cx="3703320" cy="7147983"/>
          </a:xfrm>
        </p:spPr>
        <p:txBody>
          <a:bodyPr anchor="t"/>
          <a:lstStyle>
            <a:lvl1pPr marL="0" indent="0">
              <a:buNone/>
              <a:defRPr sz="2560"/>
            </a:lvl1pPr>
            <a:lvl2pPr marL="365760" indent="0">
              <a:buNone/>
              <a:defRPr sz="2240"/>
            </a:lvl2pPr>
            <a:lvl3pPr marL="731520" indent="0">
              <a:buNone/>
              <a:defRPr sz="1920"/>
            </a:lvl3pPr>
            <a:lvl4pPr marL="1097280" indent="0">
              <a:buNone/>
              <a:defRPr sz="1600"/>
            </a:lvl4pPr>
            <a:lvl5pPr marL="1463040" indent="0">
              <a:buNone/>
              <a:defRPr sz="1600"/>
            </a:lvl5pPr>
            <a:lvl6pPr marL="1828800" indent="0">
              <a:buNone/>
              <a:defRPr sz="1600"/>
            </a:lvl6pPr>
            <a:lvl7pPr marL="2194560" indent="0">
              <a:buNone/>
              <a:defRPr sz="1600"/>
            </a:lvl7pPr>
            <a:lvl8pPr marL="2560320" indent="0">
              <a:buNone/>
              <a:defRPr sz="1600"/>
            </a:lvl8pPr>
            <a:lvl9pPr marL="2926080" indent="0">
              <a:buNone/>
              <a:defRPr sz="16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3017520"/>
            <a:ext cx="2359342" cy="5590329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6E8328-4258-9945-8338-038BE48D0508}" type="datetimeFigureOut">
              <a:rPr lang="en-US" smtClean="0"/>
              <a:t>7/2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D63DF0-34A7-064F-94E6-7FA832E74F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83943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02920" y="535519"/>
            <a:ext cx="6309360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2920" y="2677584"/>
            <a:ext cx="6309360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02920" y="9322649"/>
            <a:ext cx="164592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6E8328-4258-9945-8338-038BE48D0508}" type="datetimeFigureOut">
              <a:rPr lang="en-US" smtClean="0"/>
              <a:t>7/2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23160" y="9322649"/>
            <a:ext cx="246888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166360" y="9322649"/>
            <a:ext cx="164592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D63DF0-34A7-064F-94E6-7FA832E74F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35692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31520" rtl="0" eaLnBrk="1" latinLnBrk="0" hangingPunct="1">
        <a:lnSpc>
          <a:spcPct val="90000"/>
        </a:lnSpc>
        <a:spcBef>
          <a:spcPct val="0"/>
        </a:spcBef>
        <a:buNone/>
        <a:defRPr sz="35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2880" indent="-182880" algn="l" defTabSz="73152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2240" kern="1200">
          <a:solidFill>
            <a:schemeClr val="tx1"/>
          </a:solidFill>
          <a:latin typeface="+mn-lt"/>
          <a:ea typeface="+mn-ea"/>
          <a:cs typeface="+mn-cs"/>
        </a:defRPr>
      </a:lvl1pPr>
      <a:lvl2pPr marL="5486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92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12801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64592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201168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3774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7432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1pPr>
      <a:lvl2pPr marL="3657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2pPr>
      <a:lvl3pPr marL="7315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3pPr>
      <a:lvl4pPr marL="10972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46304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182880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1945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5603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29260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EC6011D7-FEA1-DC04-1C6C-140995D2843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06450" y="1476588"/>
            <a:ext cx="5702300" cy="233680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D4AE9167-E630-69D4-232F-2FC5D5399485}"/>
              </a:ext>
            </a:extLst>
          </p:cNvPr>
          <p:cNvSpPr txBox="1"/>
          <p:nvPr/>
        </p:nvSpPr>
        <p:spPr>
          <a:xfrm>
            <a:off x="341755" y="4133570"/>
            <a:ext cx="6973445" cy="14219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.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Transduction of patient PBMCs. (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PBMCs transduced with EBV at Day 2 exhibiting clustering on feeder cells (early transformation) and Day 34 exhibiting large floating clusters of transformed B-cells (fully transformed). The No EBV control showed no evidence of feeder clustering and died out by Day 34. (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Staining of LCL showing expression of the B-cell marker CD19.</a:t>
            </a:r>
          </a:p>
          <a:p>
            <a:endParaRPr lang="en-US" sz="2640" dirty="0"/>
          </a:p>
        </p:txBody>
      </p:sp>
    </p:spTree>
    <p:extLst>
      <p:ext uri="{BB962C8B-B14F-4D97-AF65-F5344CB8AC3E}">
        <p14:creationId xmlns:p14="http://schemas.microsoft.com/office/powerpoint/2010/main" val="325621130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6DC07D9D-4535-FEBD-E387-A1EF759D8567}"/>
              </a:ext>
            </a:extLst>
          </p:cNvPr>
          <p:cNvSpPr txBox="1"/>
          <p:nvPr/>
        </p:nvSpPr>
        <p:spPr>
          <a:xfrm>
            <a:off x="217357" y="7919432"/>
            <a:ext cx="6880485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2.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Flow cytometry images following different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B2M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editing strategies in FANCA c.3934+2T&gt;C LCL related to Figure 3D. Gating from left to right; Cells (SSC vs FSC), Singlets (FSC-Width vs FSC), Live (SSC vs eFlouro780), B2M KO (SSC vs B2M). B2M antibody was conjugated to the fluorophore PE-Cy7. (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Zap control (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CBE mRNA +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B2M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sgRNA (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ABE mRNA +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B2M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sgRNA (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Cas9 mRNA +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B2M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sgRNA.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4E980154-ACDA-B1C4-34B5-43C93D2476D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9647" y="119782"/>
            <a:ext cx="7315200" cy="77996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4205338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>
            <a:extLst>
              <a:ext uri="{FF2B5EF4-FFF2-40B4-BE49-F238E27FC236}">
                <a16:creationId xmlns:a16="http://schemas.microsoft.com/office/drawing/2014/main" id="{ED31AE6E-19A7-D9EC-AD24-F1A6F882677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84250" y="618915"/>
            <a:ext cx="5346700" cy="688340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1413423B-06D0-A8C6-186D-904C827D7EBC}"/>
              </a:ext>
            </a:extLst>
          </p:cNvPr>
          <p:cNvSpPr txBox="1"/>
          <p:nvPr/>
        </p:nvSpPr>
        <p:spPr>
          <a:xfrm>
            <a:off x="389745" y="7629994"/>
            <a:ext cx="6805534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3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omputational assessment of the feasibility of digital editing for Fanconi anemia mutations (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lgorithm used for classification of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ClinVar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mutations into base editable, prime editable, or requiring an alternative correction method. These strategies are towards a principle of universal editing, where any nucleic acid modification can be converted to another. (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Percentage of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ClinVar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Fanconi Anemia associated mutations by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bonafide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Fanconi Anemia genes. Note that values are unadjusted for prevalence of mutation in patients. 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8131545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Google Shape;278;p26">
            <a:extLst>
              <a:ext uri="{FF2B5EF4-FFF2-40B4-BE49-F238E27FC236}">
                <a16:creationId xmlns:a16="http://schemas.microsoft.com/office/drawing/2014/main" id="{766C13C4-7563-33AE-FA14-DDCF5C8FE459}"/>
              </a:ext>
            </a:extLst>
          </p:cNvPr>
          <p:cNvGraphicFramePr/>
          <p:nvPr/>
        </p:nvGraphicFramePr>
        <p:xfrm>
          <a:off x="-21194" y="945276"/>
          <a:ext cx="7357587" cy="4720743"/>
        </p:xfrm>
        <a:graphic>
          <a:graphicData uri="http://schemas.openxmlformats.org/drawingml/2006/table">
            <a:tbl>
              <a:tblPr>
                <a:noFill/>
              </a:tblPr>
              <a:tblGrid>
                <a:gridCol w="50919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917088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959639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726002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594759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650902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137148"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b="1" u="none" strike="noStrike" cap="none" dirty="0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gene</a:t>
                      </a:r>
                      <a:endParaRPr sz="1800" dirty="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b="1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ensembl_id</a:t>
                      </a:r>
                      <a:endParaRPr sz="600" b="1" u="none" strike="noStrike" cap="none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b="1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alt_gene_name</a:t>
                      </a:r>
                      <a:endParaRPr sz="600" b="1" u="none" strike="noStrike" cap="none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b="1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description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b="1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cancer_predisposition_syndrome</a:t>
                      </a:r>
                      <a:endParaRPr sz="600" b="1" u="none" strike="noStrike" cap="none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b="1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bona_fide_fa</a:t>
                      </a:r>
                      <a:endParaRPr sz="600" b="1" u="none" strike="noStrike" cap="none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37148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i="1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NCA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b="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ENSG00000187741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600" u="none" strike="noStrike" cap="none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nconi anaemia core complex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LSE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TRUE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37148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i="1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NCB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b="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ENSG00000181544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600" u="none" strike="noStrike" cap="none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nconi anaemia core complex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 dirty="0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LSE</a:t>
                      </a:r>
                      <a:endParaRPr sz="1800" dirty="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TRUE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37148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i="1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NCC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b="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ENSG00000158169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600" u="none" strike="noStrike" cap="none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nconi anaemia core complex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LSE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TRUE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37148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i="1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NCD1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b="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ENSG00000139618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i="1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BRCA2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Homologous recombination and fork stabilization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TRUE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TRUE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37148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i="1" u="none" strike="noStrike" cap="none" dirty="0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NCD2</a:t>
                      </a:r>
                      <a:endParaRPr sz="1800" dirty="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b="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ENSG00000144554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8F8F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600" u="none" strike="noStrike" cap="none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Binds to FANCI; has multiple functions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LSE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TRUE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37148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i="1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NCE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b="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ENSG00000112039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8F8F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600" u="none" strike="noStrike" cap="none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nconi anaemia core complex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LSE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TRUE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37148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i="1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NCF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b="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ENSG00000183161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600" u="none" strike="noStrike" cap="none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nconi anaemia core complex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LSE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TRUE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37148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i="1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NCG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b="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ENSG00000221829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i="1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XRCC9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nconi anaemia core complex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LSE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TRUE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37148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i="1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NCI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b="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ENSG00000140525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600" u="none" strike="noStrike" cap="none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Binds FANCD2; has multiple functions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LSE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TRUE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37148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i="1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NCJ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b="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ENSG00000136492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i="1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BRIP1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Homologous recombination and translesion synthesis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LSE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TRUE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45689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i="1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NCL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b="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ENSG00000115392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600" u="none" strike="noStrike" cap="none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nconi anaemia core complex; E3 ubiquitin ligase for FANCD2–I ubiquitylation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LSE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TRUE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37148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i="1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NCN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b="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ENSG00000083093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8F8F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i="1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PALB2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Homologous recombination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TRUE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TRUE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37148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i="1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NCP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b="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ENSG00000188827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i="1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SLX4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Nuclease scaffold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LSE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TRUE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37148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i="1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NCQ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b="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ENSG00000175595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i="1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ERCC4, XPF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DNA incision, functions in nucleotide excision repair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LSE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TRUE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37148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i="1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NCT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b="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ENSG00000077152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8F8F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i="1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BE2T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nconi anaemia core complex; E2 ubiquitin ligase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LSE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TRUE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37148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i="1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NCM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b="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ENSG00000187790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AP250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nconi anaemia core complex; lesion recognition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LSE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LSE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37148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i="1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NCO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b="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ENSG00000108384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i="1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RAD51C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Homologous recombination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TRUE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LSE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137148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i="1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NCR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b="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ENSG00000051180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i="1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RAD51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Homologous recombination and fork stabilization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LSE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LSE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137148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i="1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NCS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b="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ENSG00000012048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i="1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BRCA1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Homologous recombination and fork stabilization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LSE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LSE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137148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i="1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NCU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b="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ENSG00000196584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i="1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XRCC2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Homologous recombination and fork stabilization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LSE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TRUE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137148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i="1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NCV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b="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ENSG00000116670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i="1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MAD2L2, REV7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DNA polymerization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LSE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TRUE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137148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i="1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NCW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b="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ENSG00000168411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RFWD3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biquitin ligase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LSE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TRUE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137148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i="1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AP100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b="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ENSG00000185504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8F8F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600" u="none" strike="noStrike" cap="none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nconi anaemia core complex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LSE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LSE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137148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i="1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AP24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b="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ENSG00000131944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600" u="none" strike="noStrike" cap="none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nconi anaemia core complex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LSE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LSE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137148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i="1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AP20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b="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ENSG00000162585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600" u="none" strike="noStrike" cap="none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nconi anaemia core complex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LSE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LSE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  <a:tr h="223466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i="1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AP16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b="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ENSG00000175279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i="1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MHF1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nconi anaemia core complex; histone fold-containing protein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LSE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LSE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6"/>
                  </a:ext>
                </a:extLst>
              </a:tr>
              <a:tr h="137148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i="1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AP10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b="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ENSG00000169689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i="1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MHF2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nconi anaemia core complex; histone fold-containing protein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LSE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LSE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7"/>
                  </a:ext>
                </a:extLst>
              </a:tr>
              <a:tr h="137148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i="1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BOD1L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b="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ENSG00000038219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600" u="none" strike="noStrike" cap="none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RAD51 nucleofilament stabilization and fork stabilization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LSE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LSE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8"/>
                  </a:ext>
                </a:extLst>
              </a:tr>
              <a:tr h="137148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i="1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HRF1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b="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ENSG00000276043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8F8F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600" u="none" strike="noStrike" cap="none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Lesion recognition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LSE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LSE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9"/>
                  </a:ext>
                </a:extLst>
              </a:tr>
              <a:tr h="137148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i="1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SP1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b="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ENSG00000162607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600" u="none" strike="noStrike" cap="none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NCD2–I deubiquitylation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LSE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LSE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0"/>
                  </a:ext>
                </a:extLst>
              </a:tr>
              <a:tr h="137148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i="1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AF1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b="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ENST00000568933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600" u="none" strike="noStrike" cap="none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NCD2–I deubiquitylation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LSE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LSE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1"/>
                  </a:ext>
                </a:extLst>
              </a:tr>
              <a:tr h="137148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i="1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N1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b="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ENSG00000198690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600" u="none" strike="noStrike" cap="none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Nuclease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LSE</a:t>
                      </a:r>
                      <a:endParaRPr sz="180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600" u="none" strike="noStrike" cap="none" dirty="0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LSE</a:t>
                      </a:r>
                      <a:endParaRPr sz="1800" dirty="0"/>
                    </a:p>
                  </a:txBody>
                  <a:tcPr marL="18075" marR="18075" marT="12050" marB="12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2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30713958-05E1-BF8F-BB87-594B1BD930C3}"/>
              </a:ext>
            </a:extLst>
          </p:cNvPr>
          <p:cNvSpPr txBox="1"/>
          <p:nvPr/>
        </p:nvSpPr>
        <p:spPr>
          <a:xfrm>
            <a:off x="0" y="323131"/>
            <a:ext cx="9664908" cy="45653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400" b="1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Supplementary Table S1.</a:t>
            </a:r>
            <a:r>
              <a:rPr lang="en-US" sz="14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Table of genes mutated in Fanconi anemia used in analysis</a:t>
            </a:r>
            <a:r>
              <a:rPr lang="en-US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251906007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 descr="Timeline&#10;&#10;Description automatically generated">
            <a:extLst>
              <a:ext uri="{FF2B5EF4-FFF2-40B4-BE49-F238E27FC236}">
                <a16:creationId xmlns:a16="http://schemas.microsoft.com/office/drawing/2014/main" id="{3751BAF0-8419-6186-A2D5-85E72D18031C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/>
          <a:srcRect r="30320"/>
          <a:stretch/>
        </p:blipFill>
        <p:spPr>
          <a:xfrm>
            <a:off x="1070662" y="3232124"/>
            <a:ext cx="1819207" cy="2610803"/>
          </a:xfr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3ABC479F-3DFB-9AFC-FF72-9F2B4A622EBB}"/>
              </a:ext>
            </a:extLst>
          </p:cNvPr>
          <p:cNvSpPr txBox="1"/>
          <p:nvPr/>
        </p:nvSpPr>
        <p:spPr>
          <a:xfrm>
            <a:off x="1254936" y="6021270"/>
            <a:ext cx="470444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Data S1.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Original Western blot images for FANCA (a) and for FANCD2 (b).</a:t>
            </a:r>
            <a:endParaRPr lang="en-US" sz="1200" dirty="0"/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38BFEDE8-678E-4AFA-0C7B-33373498CB5E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6180" b="13839"/>
          <a:stretch/>
        </p:blipFill>
        <p:spPr>
          <a:xfrm>
            <a:off x="3436932" y="3345636"/>
            <a:ext cx="2522452" cy="2610803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46A6D736-2FA3-FF7B-B2EA-CCEB68E4ACE4}"/>
              </a:ext>
            </a:extLst>
          </p:cNvPr>
          <p:cNvSpPr txBox="1"/>
          <p:nvPr/>
        </p:nvSpPr>
        <p:spPr>
          <a:xfrm>
            <a:off x="725215" y="3280804"/>
            <a:ext cx="529721" cy="2585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8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E51AA3E-D284-3942-0715-CA9F330BA01A}"/>
              </a:ext>
            </a:extLst>
          </p:cNvPr>
          <p:cNvSpPr txBox="1"/>
          <p:nvPr/>
        </p:nvSpPr>
        <p:spPr>
          <a:xfrm>
            <a:off x="3294994" y="3280804"/>
            <a:ext cx="529721" cy="2585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8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9245519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</TotalTime>
  <Words>618</Words>
  <Application>Microsoft Office PowerPoint</Application>
  <PresentationFormat>Custom</PresentationFormat>
  <Paragraphs>191</Paragraphs>
  <Slides>5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ristopher J Sipe</dc:creator>
  <cp:lastModifiedBy>MDPI</cp:lastModifiedBy>
  <cp:revision>10</cp:revision>
  <dcterms:created xsi:type="dcterms:W3CDTF">2022-06-15T20:37:55Z</dcterms:created>
  <dcterms:modified xsi:type="dcterms:W3CDTF">2022-07-26T03:03:58Z</dcterms:modified>
</cp:coreProperties>
</file>